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media/image7.jpeg" ContentType="image/jpe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95D97-6A95-41C4-B31B-5348FFE448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194D6-329D-4737-B149-09CE87C521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9425D-6DDC-4B4D-8559-8E8A5484BF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15037-CA6F-438F-8202-7DCAACD0D2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31287-9A08-4EF3-9FDB-00199C230E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C1439-2A07-4305-9BAA-AAB19E4E73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29DB1-458E-4306-AFB9-E798A434CB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55A94-3C87-45BB-8C0E-CDB6133508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9A10B-4AFD-4BBB-853A-1AF93D46E3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95BD4-CC2A-42E9-879A-6016789919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ED4DA-6DA7-4A7D-8EC8-516DF2546F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7DBBE-8749-4282-9584-96EF1D54D1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A1A247-FFEC-4B79-B126-EBE9AA0E30E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7754760" y="5384880"/>
            <a:ext cx="150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3A; Actin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9"/>
          <p:cNvSpPr/>
          <p:nvPr/>
        </p:nvSpPr>
        <p:spPr>
          <a:xfrm>
            <a:off x="2836800" y="5421240"/>
            <a:ext cx="150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3A; HO-1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5"/>
          <p:cNvSpPr/>
          <p:nvPr/>
        </p:nvSpPr>
        <p:spPr>
          <a:xfrm>
            <a:off x="2859120" y="2359080"/>
            <a:ext cx="18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3A; SIRT1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9"/>
          <p:cNvSpPr/>
          <p:nvPr/>
        </p:nvSpPr>
        <p:spPr>
          <a:xfrm>
            <a:off x="7574040" y="2270160"/>
            <a:ext cx="18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3A; Nrf2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1"/>
          <p:cNvSpPr/>
          <p:nvPr/>
        </p:nvSpPr>
        <p:spPr>
          <a:xfrm>
            <a:off x="184320" y="19368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"/>
          <p:cNvSpPr/>
          <p:nvPr/>
        </p:nvSpPr>
        <p:spPr>
          <a:xfrm>
            <a:off x="2862360" y="6410160"/>
            <a:ext cx="77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3. A) Western blots are performed, and SIRT1, Nrf2, HO-1, and Actin proteins bands are show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1" descr=""/>
          <p:cNvPicPr/>
          <p:nvPr/>
        </p:nvPicPr>
        <p:blipFill>
          <a:blip r:embed="rId1"/>
          <a:stretch/>
        </p:blipFill>
        <p:spPr>
          <a:xfrm>
            <a:off x="6359400" y="3546360"/>
            <a:ext cx="4589640" cy="17780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"/>
          <p:cNvPicPr/>
          <p:nvPr/>
        </p:nvPicPr>
        <p:blipFill>
          <a:blip r:embed="rId2"/>
          <a:stretch/>
        </p:blipFill>
        <p:spPr>
          <a:xfrm>
            <a:off x="1084320" y="3521160"/>
            <a:ext cx="5035320" cy="18651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3"/>
          <a:stretch/>
        </p:blipFill>
        <p:spPr>
          <a:xfrm>
            <a:off x="1258920" y="608040"/>
            <a:ext cx="4238640" cy="17431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4"/>
          <a:stretch/>
        </p:blipFill>
        <p:spPr>
          <a:xfrm>
            <a:off x="6373800" y="520560"/>
            <a:ext cx="3876840" cy="1781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21"/>
          <p:cNvSpPr/>
          <p:nvPr/>
        </p:nvSpPr>
        <p:spPr>
          <a:xfrm>
            <a:off x="184320" y="19368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2368440" y="3803760"/>
            <a:ext cx="182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4E; Actin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3"/>
          <p:cNvSpPr/>
          <p:nvPr/>
        </p:nvSpPr>
        <p:spPr>
          <a:xfrm>
            <a:off x="7445520" y="3781440"/>
            <a:ext cx="18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4E; Nrf2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1"/>
          <p:cNvSpPr/>
          <p:nvPr/>
        </p:nvSpPr>
        <p:spPr>
          <a:xfrm>
            <a:off x="2862360" y="5116680"/>
            <a:ext cx="77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. E) Western blots are performed, and Actin and Nrf2 proteins bands were show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" descr=""/>
          <p:cNvPicPr/>
          <p:nvPr/>
        </p:nvPicPr>
        <p:blipFill>
          <a:blip r:embed="rId1"/>
          <a:srcRect l="3929" t="0" r="2279" b="0"/>
          <a:stretch/>
        </p:blipFill>
        <p:spPr>
          <a:xfrm>
            <a:off x="949320" y="2000160"/>
            <a:ext cx="4734000" cy="17877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" descr=""/>
          <p:cNvPicPr/>
          <p:nvPr/>
        </p:nvPicPr>
        <p:blipFill>
          <a:blip r:embed="rId2"/>
          <a:stretch/>
        </p:blipFill>
        <p:spPr>
          <a:xfrm>
            <a:off x="6162840" y="2017800"/>
            <a:ext cx="4590720" cy="178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21"/>
          <p:cNvSpPr/>
          <p:nvPr/>
        </p:nvSpPr>
        <p:spPr>
          <a:xfrm>
            <a:off x="184320" y="19368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5"/>
          <p:cNvSpPr/>
          <p:nvPr/>
        </p:nvSpPr>
        <p:spPr>
          <a:xfrm>
            <a:off x="2208240" y="4145040"/>
            <a:ext cx="18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4F; SIRT1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3"/>
          <p:cNvSpPr/>
          <p:nvPr/>
        </p:nvSpPr>
        <p:spPr>
          <a:xfrm>
            <a:off x="7443720" y="4187880"/>
            <a:ext cx="182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4F; Actin G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"/>
          <p:cNvSpPr/>
          <p:nvPr/>
        </p:nvSpPr>
        <p:spPr>
          <a:xfrm>
            <a:off x="2862360" y="5116680"/>
            <a:ext cx="77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. F) Western blots are performed, and SIRT1 and Actin proteins bands were show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1" descr=""/>
          <p:cNvPicPr/>
          <p:nvPr/>
        </p:nvPicPr>
        <p:blipFill>
          <a:blip r:embed="rId1"/>
          <a:stretch/>
        </p:blipFill>
        <p:spPr>
          <a:xfrm>
            <a:off x="5676840" y="2579760"/>
            <a:ext cx="4587840" cy="16254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"/>
          <p:cNvPicPr/>
          <p:nvPr/>
        </p:nvPicPr>
        <p:blipFill>
          <a:blip r:embed="rId2"/>
          <a:stretch/>
        </p:blipFill>
        <p:spPr>
          <a:xfrm>
            <a:off x="990720" y="2508120"/>
            <a:ext cx="4194000" cy="154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3-27T10:01:14Z</dcterms:created>
  <dc:creator>Sukumar Biswas</dc:creator>
  <dc:description/>
  <dc:language>en-US</dc:language>
  <cp:lastModifiedBy>Sukumar Biswas</cp:lastModifiedBy>
  <dcterms:modified xsi:type="dcterms:W3CDTF">2023-03-13T05:15:01Z</dcterms:modified>
  <cp:revision>12</cp:revision>
  <dc:subject/>
  <dc:title>PowerPoint Presentation</dc:title>
</cp:coreProperties>
</file>